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61E910-D33E-4976-BCA2-8398FCE1168F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873DF5-1B64-47B3-B950-C2857CADF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138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Supplemental Figure 1. Sequence alignment of Rsr1 from </a:t>
            </a:r>
            <a:r>
              <a:rPr lang="en-US" i="1" dirty="0"/>
              <a:t>Saccharomyces cerevisiae </a:t>
            </a:r>
            <a:r>
              <a:rPr lang="en-US" dirty="0"/>
              <a:t>and </a:t>
            </a:r>
            <a:r>
              <a:rPr lang="en-US" i="1" dirty="0"/>
              <a:t>Aspergillus fumigatus</a:t>
            </a:r>
            <a:r>
              <a:rPr lang="en-US" dirty="0"/>
              <a:t>. Identical amino acids residues are shaded. The GTP/GDP-binding motifs, core effector domain, highly variable region (HVR), and CAAX motif are indicated above the sequ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76B02A-5A1D-4C6E-BC2E-9D64FA7396C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2300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459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979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283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1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942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292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578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495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667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69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098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788A8-8C77-4994-8BDB-93D93F8C4303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4EA46-1B5F-4758-B8ED-08D7DA87D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8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421737" y="1088433"/>
            <a:ext cx="7599173" cy="4521508"/>
            <a:chOff x="1518459" y="773699"/>
            <a:chExt cx="7599173" cy="452150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/>
            <a:srcRect l="44546" t="13483" r="11240" b="6474"/>
            <a:stretch/>
          </p:blipFill>
          <p:spPr>
            <a:xfrm>
              <a:off x="1518459" y="773699"/>
              <a:ext cx="7599173" cy="4521508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144517" y="947651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5361685" y="947651"/>
              <a:ext cx="1183873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4297143" y="955964"/>
              <a:ext cx="441850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2696509" y="955964"/>
              <a:ext cx="1476650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>
              <a:off x="6646539" y="955964"/>
              <a:ext cx="214862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1733482" y="1823259"/>
              <a:ext cx="319761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977196" y="947651"/>
              <a:ext cx="98277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260515" y="1823259"/>
              <a:ext cx="966966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332109" y="1823259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3545401" y="1823259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5048138" y="1823259"/>
              <a:ext cx="215326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4620469" y="1823259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773194" y="1823259"/>
              <a:ext cx="538339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5370897" y="1823259"/>
              <a:ext cx="204022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5701814" y="1823259"/>
              <a:ext cx="524059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6440661" y="1826031"/>
              <a:ext cx="420739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7194862" y="1823259"/>
              <a:ext cx="197729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7514040" y="1823259"/>
              <a:ext cx="100859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838476" y="2715491"/>
              <a:ext cx="214095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7830566" y="1823259"/>
              <a:ext cx="338364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357929" y="2704409"/>
              <a:ext cx="126887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555388" y="2715491"/>
              <a:ext cx="103580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855142" y="2715491"/>
              <a:ext cx="232002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4296521" y="2715491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5259879" y="2707181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5470357" y="2718263"/>
              <a:ext cx="216242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5801773" y="2715491"/>
              <a:ext cx="300685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6224288" y="2718263"/>
              <a:ext cx="203462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6545558" y="2715491"/>
              <a:ext cx="529896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7288943" y="2718263"/>
              <a:ext cx="127704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1931458" y="3632662"/>
              <a:ext cx="114699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5579881" y="3632662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5789758" y="3632662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6008516" y="3632662"/>
              <a:ext cx="114792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293128" y="4544293"/>
              <a:ext cx="209843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5040346" y="4544293"/>
              <a:ext cx="116378" cy="498764"/>
            </a:xfrm>
            <a:prstGeom prst="rect">
              <a:avLst/>
            </a:prstGeom>
            <a:solidFill>
              <a:srgbClr val="44546A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182614" y="1467528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A. fumigatus </a:t>
            </a:r>
            <a:r>
              <a:rPr lang="en-US" sz="1200" b="1" dirty="0" err="1"/>
              <a:t>RsrA</a:t>
            </a:r>
            <a:endParaRPr lang="en-US" sz="12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83793" y="1243083"/>
            <a:ext cx="128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S. cerevisiae </a:t>
            </a:r>
            <a:r>
              <a:rPr lang="en-US" sz="1200" b="1" dirty="0"/>
              <a:t>Rsr1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84627" y="2356429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A. fumigatus </a:t>
            </a:r>
            <a:r>
              <a:rPr lang="en-US" sz="1200" b="1" dirty="0" err="1"/>
              <a:t>RsrA</a:t>
            </a:r>
            <a:endParaRPr lang="en-US" sz="12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189553" y="2133911"/>
            <a:ext cx="128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S. cerevisiae </a:t>
            </a:r>
            <a:r>
              <a:rPr lang="en-US" sz="1200" b="1" dirty="0"/>
              <a:t>Rsr1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87015" y="3258720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A. fumigatus </a:t>
            </a:r>
            <a:r>
              <a:rPr lang="en-US" sz="1200" b="1" dirty="0" err="1"/>
              <a:t>RsrA</a:t>
            </a:r>
            <a:endParaRPr lang="en-US" sz="12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82822" y="3047637"/>
            <a:ext cx="128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S. cerevisiae </a:t>
            </a:r>
            <a:r>
              <a:rPr lang="en-US" sz="1200" b="1" dirty="0"/>
              <a:t>Rsr1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87015" y="4160963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A. fumigatus </a:t>
            </a:r>
            <a:r>
              <a:rPr lang="en-US" sz="1200" b="1" dirty="0" err="1"/>
              <a:t>RsrA</a:t>
            </a:r>
            <a:endParaRPr lang="en-US" sz="12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184311" y="3926733"/>
            <a:ext cx="128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S. cerevisiae </a:t>
            </a:r>
            <a:r>
              <a:rPr lang="en-US" sz="1200" b="1" dirty="0"/>
              <a:t>Rsr1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88746" y="5011521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A. fumigatus </a:t>
            </a:r>
            <a:r>
              <a:rPr lang="en-US" sz="1200" b="1" dirty="0" err="1"/>
              <a:t>RsrA</a:t>
            </a:r>
            <a:endParaRPr lang="en-US" sz="12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182823" y="4787076"/>
            <a:ext cx="128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/>
              <a:t>S. cerevisiae </a:t>
            </a:r>
            <a:r>
              <a:rPr lang="en-US" sz="1200" b="1" dirty="0"/>
              <a:t>Rsr1</a:t>
            </a:r>
          </a:p>
        </p:txBody>
      </p:sp>
      <p:sp>
        <p:nvSpPr>
          <p:cNvPr id="57" name="Rectangle 56"/>
          <p:cNvSpPr/>
          <p:nvPr/>
        </p:nvSpPr>
        <p:spPr>
          <a:xfrm>
            <a:off x="2264260" y="1262385"/>
            <a:ext cx="116378" cy="498764"/>
          </a:xfrm>
          <a:prstGeom prst="rect">
            <a:avLst/>
          </a:prstGeom>
          <a:solidFill>
            <a:srgbClr val="44546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7523907" y="1262385"/>
            <a:ext cx="530671" cy="498764"/>
          </a:xfrm>
          <a:prstGeom prst="rect">
            <a:avLst/>
          </a:prstGeom>
          <a:solidFill>
            <a:srgbClr val="44546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4406249" y="3030225"/>
            <a:ext cx="549067" cy="498764"/>
          </a:xfrm>
          <a:prstGeom prst="rect">
            <a:avLst/>
          </a:prstGeom>
          <a:solidFill>
            <a:srgbClr val="44546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5163155" y="4859027"/>
            <a:ext cx="210478" cy="498764"/>
          </a:xfrm>
          <a:prstGeom prst="rect">
            <a:avLst/>
          </a:prstGeom>
          <a:solidFill>
            <a:srgbClr val="44546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Connector 38"/>
          <p:cNvCxnSpPr/>
          <p:nvPr/>
        </p:nvCxnSpPr>
        <p:spPr>
          <a:xfrm flipV="1">
            <a:off x="5281170" y="1231196"/>
            <a:ext cx="1072012" cy="307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5264963" y="992807"/>
            <a:ext cx="1203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ffector domain</a:t>
            </a:r>
          </a:p>
        </p:txBody>
      </p:sp>
      <p:cxnSp>
        <p:nvCxnSpPr>
          <p:cNvPr id="61" name="Straight Connector 60"/>
          <p:cNvCxnSpPr/>
          <p:nvPr/>
        </p:nvCxnSpPr>
        <p:spPr>
          <a:xfrm>
            <a:off x="4941989" y="4830746"/>
            <a:ext cx="42221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4758347" y="4594117"/>
            <a:ext cx="8067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AAX box</a:t>
            </a:r>
          </a:p>
        </p:txBody>
      </p:sp>
      <p:cxnSp>
        <p:nvCxnSpPr>
          <p:cNvPr id="64" name="Straight Connector 63"/>
          <p:cNvCxnSpPr/>
          <p:nvPr/>
        </p:nvCxnSpPr>
        <p:spPr>
          <a:xfrm>
            <a:off x="2941136" y="1234266"/>
            <a:ext cx="82125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7535933" y="1231196"/>
            <a:ext cx="486825" cy="307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1636760" y="2102666"/>
            <a:ext cx="3190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7748646" y="2120055"/>
            <a:ext cx="3190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1677708" y="3011365"/>
            <a:ext cx="2711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4532353" y="2969841"/>
            <a:ext cx="4112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3008094" y="994266"/>
            <a:ext cx="777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TP/GDP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7433446" y="988204"/>
            <a:ext cx="777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TP/GDP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4359345" y="2753228"/>
            <a:ext cx="777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TP/GDP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7553369" y="1868042"/>
            <a:ext cx="777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TP/GDP</a:t>
            </a:r>
          </a:p>
        </p:txBody>
      </p:sp>
      <p:cxnSp>
        <p:nvCxnSpPr>
          <p:cNvPr id="68" name="Straight Connector 67"/>
          <p:cNvCxnSpPr/>
          <p:nvPr/>
        </p:nvCxnSpPr>
        <p:spPr>
          <a:xfrm>
            <a:off x="2328627" y="3925265"/>
            <a:ext cx="5715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1636758" y="4836965"/>
            <a:ext cx="25603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934511" y="3686319"/>
            <a:ext cx="46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HVR</a:t>
            </a:r>
            <a:endParaRPr lang="en-US" sz="12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2670375" y="4594116"/>
            <a:ext cx="46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HVR</a:t>
            </a:r>
            <a:endParaRPr lang="en-US" sz="1200" b="1" dirty="0"/>
          </a:p>
        </p:txBody>
      </p:sp>
      <p:sp>
        <p:nvSpPr>
          <p:cNvPr id="80" name="Rectangle 79"/>
          <p:cNvSpPr/>
          <p:nvPr/>
        </p:nvSpPr>
        <p:spPr>
          <a:xfrm>
            <a:off x="4729853" y="1263337"/>
            <a:ext cx="116378" cy="498764"/>
          </a:xfrm>
          <a:prstGeom prst="rect">
            <a:avLst/>
          </a:prstGeom>
          <a:solidFill>
            <a:srgbClr val="44546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4300285" y="2140765"/>
            <a:ext cx="116378" cy="498764"/>
          </a:xfrm>
          <a:prstGeom prst="rect">
            <a:avLst/>
          </a:prstGeom>
          <a:solidFill>
            <a:srgbClr val="44546A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361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-Vicente, Adela</dc:creator>
  <cp:lastModifiedBy>Martin-Vicente, Adela</cp:lastModifiedBy>
  <cp:revision>1</cp:revision>
  <dcterms:created xsi:type="dcterms:W3CDTF">2020-09-15T20:09:16Z</dcterms:created>
  <dcterms:modified xsi:type="dcterms:W3CDTF">2020-09-15T20:09:35Z</dcterms:modified>
</cp:coreProperties>
</file>